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EE86028-A820-4740-B175-FDBEA3468AA9}" v="1" dt="2025-10-30T16:09:28.50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>
      <p:cViewPr varScale="1">
        <p:scale>
          <a:sx n="66" d="100"/>
          <a:sy n="66" d="100"/>
        </p:scale>
        <p:origin x="6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mertzidou, Anysia" userId="a7f71f62-1794-4728-88f7-f0b545a7c8aa" providerId="ADAL" clId="{BEE86028-A820-4740-B175-FDBEA3468AA9}"/>
    <pc:docChg chg="modSld">
      <pc:chgData name="Semertzidou, Anysia" userId="a7f71f62-1794-4728-88f7-f0b545a7c8aa" providerId="ADAL" clId="{BEE86028-A820-4740-B175-FDBEA3468AA9}" dt="2025-10-30T16:10:00.545" v="16" actId="113"/>
      <pc:docMkLst>
        <pc:docMk/>
      </pc:docMkLst>
      <pc:sldChg chg="addSp modSp mod">
        <pc:chgData name="Semertzidou, Anysia" userId="a7f71f62-1794-4728-88f7-f0b545a7c8aa" providerId="ADAL" clId="{BEE86028-A820-4740-B175-FDBEA3468AA9}" dt="2025-10-30T16:10:00.545" v="16" actId="113"/>
        <pc:sldMkLst>
          <pc:docMk/>
          <pc:sldMk cId="3569588777" sldId="256"/>
        </pc:sldMkLst>
        <pc:spChg chg="add mod">
          <ac:chgData name="Semertzidou, Anysia" userId="a7f71f62-1794-4728-88f7-f0b545a7c8aa" providerId="ADAL" clId="{BEE86028-A820-4740-B175-FDBEA3468AA9}" dt="2025-10-30T16:09:45.294" v="13" actId="113"/>
          <ac:spMkLst>
            <pc:docMk/>
            <pc:sldMk cId="3569588777" sldId="256"/>
            <ac:spMk id="2" creationId="{1BED2735-6724-853F-22C9-651E418F1D06}"/>
          </ac:spMkLst>
        </pc:spChg>
        <pc:spChg chg="add mod">
          <ac:chgData name="Semertzidou, Anysia" userId="a7f71f62-1794-4728-88f7-f0b545a7c8aa" providerId="ADAL" clId="{BEE86028-A820-4740-B175-FDBEA3468AA9}" dt="2025-10-30T16:10:00.545" v="16" actId="113"/>
          <ac:spMkLst>
            <pc:docMk/>
            <pc:sldMk cId="3569588777" sldId="256"/>
            <ac:spMk id="5" creationId="{69396E42-DC61-3918-0FA0-23C85819057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044973-ED03-1123-4D6E-0EE7125266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6B95369-7872-663D-5F5E-9AE3F93CE8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5E0F70-0580-D4EC-59A9-ADECBE9B1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C565F3-250C-46BA-C87B-B87A1FDB0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A529F3-8CAF-1055-31D4-9A97945FC4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563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5F97C-7C1B-5ACC-C555-0863E349C2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0261B7-E39E-4869-F699-0052C95904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3F89E1-91D2-04E8-D6CD-BC39CCCB7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F38F4-BBFC-0E7D-3A45-537D2F983D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E36B4-6B6B-BAF2-B942-0B89342B3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9728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AE9EF9-1DA7-CCFC-13B7-D89E4C49E1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CAC249-CB66-831A-DE13-E51845115A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7A1B58-6529-7F2A-03A6-BBB7016FE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1EFD40-9526-2158-FBDF-9FD44B376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FBB1A5-E7D0-BCDF-401C-4E2497DACD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33373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1F2BF9-3EB6-B841-CB1B-8B5743E5EF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CE2FC8-703F-7B2C-B705-50E4677DB6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4C65FF-088E-EEB5-0F19-7DF46D20C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FCDABD-C210-7FA7-3DC4-5681DABA8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1F7071-F399-09CB-E09E-8D4AE0BFF9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2648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411734-F07D-FF9B-754A-F8FFA8946E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FAC8FED-EAA3-6B6F-C456-9DE949E03B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39430-70FC-DCA7-11E9-CB794CDAE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E0652E-7E38-F565-AE97-2899EFB69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0CC48D-83CF-5D72-185E-B60C5EA709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9003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1981DF-3DA8-1167-3929-B45A7DDEED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694627-C616-5460-9543-7E2F7E4F28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59584B6-3E2B-8130-630E-8398209DF1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42CC4F-87A8-0234-F057-006EB29E8E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64A664-687E-208F-E9AE-D4FD6F31D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2F5A84-254F-4AC0-F30D-02BD32B1B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58129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92D29-0153-9725-2AFA-BF249AC7A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0D0E8E-8542-08A3-1B46-C3B123DA02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6339151-39BB-39E8-FD7D-0F77ACEC95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8202363-EBEF-F487-2C13-573BBB7BBF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BB13FF-50C6-482B-9539-E2C869EFAC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056332-A208-7CFF-F34B-12FDFD0EDE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B2AC30F-0A26-E0C6-8FBB-2E2181803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FFB2D9-56ED-F085-7A2E-67D6910A1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4935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3A0657-F34A-5FA8-A95E-28854C2382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6E9C1E-2195-683F-F367-49BFE68A5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093F21-54A7-4FE6-4EFE-AD913AA32A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08BE81-4472-6C20-8EC5-CFC45B133C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7426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3FD1A56-B5AB-072E-3D21-C9A8B097B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92D28A-7FDB-B321-24E1-1ED2215BF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AA1BD1-6FFC-F878-7BF6-E8AAD86B62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5269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FC52A-C77E-2207-FCAD-C83F28236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D5ABB4-14CB-C33E-54B4-37BE135BE3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9B9ED7-6D85-42BA-3E23-D93C60EB48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BAA3BF-02B9-0785-E1C7-C2579DEEC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B5F9C9-5E90-7CD0-F48C-C4EADEABE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D8E00F-5B9B-D53B-2E9A-0F53A10072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0785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2220A-9404-AD5F-C607-A4909D8C6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608C26-0288-0761-A2E7-5379A12B32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E504AD-2ACE-B6D8-2A86-C3CA85A83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88E1DA-CF8E-B81D-7BFF-E5A5F689B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0514B-C031-1474-91F8-BDD38DF45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969DB8-4619-DE1F-5AF7-18441ED94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630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40085C-259A-6890-0ACF-99659D9919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99CE81-632C-CA2B-6F99-99F8A110C2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6D2D89-8625-04E5-9451-BD41F770E6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62EB18-29B3-4010-85D3-859E0AA5E439}" type="datetimeFigureOut">
              <a:rPr lang="en-GB" smtClean="0"/>
              <a:t>30/10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325D46-B141-45C5-CABE-EE936FE58F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D06DE7-CD15-B12A-6DE7-14FCDB154D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F04982-15F0-4A5B-A781-165E500115D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11778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diagram of different colored lines&#10;&#10;Description automatically generated with medium confidence">
            <a:extLst>
              <a:ext uri="{FF2B5EF4-FFF2-40B4-BE49-F238E27FC236}">
                <a16:creationId xmlns:a16="http://schemas.microsoft.com/office/drawing/2014/main" id="{CC98A714-C7D7-F9C5-02BF-CD147C15DA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0245" y="1741170"/>
            <a:ext cx="5731510" cy="3375660"/>
          </a:xfrm>
          <a:prstGeom prst="rect">
            <a:avLst/>
          </a:prstGeom>
        </p:spPr>
      </p:pic>
      <p:sp>
        <p:nvSpPr>
          <p:cNvPr id="2" name="Text Box 19">
            <a:extLst>
              <a:ext uri="{FF2B5EF4-FFF2-40B4-BE49-F238E27FC236}">
                <a16:creationId xmlns:a16="http://schemas.microsoft.com/office/drawing/2014/main" id="{1BED2735-6724-853F-22C9-651E418F1D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9182" y="5453948"/>
            <a:ext cx="5685155" cy="62773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Figure 4 shows </a:t>
            </a:r>
            <a:r>
              <a:rPr lang="en-GB" sz="1100" i="1" kern="100" dirty="0"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e</a:t>
            </a:r>
            <a:r>
              <a:rPr lang="en-GB" sz="1100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xpression of interferon signalling genes in different ovarian cancer subtypes, p-value is comparing the high-grade distribution against all other subtypes combined.</a:t>
            </a:r>
            <a:endParaRPr lang="en-GB" sz="1100" kern="1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9396E42-DC61-3918-0FA0-23C85819057D}"/>
              </a:ext>
            </a:extLst>
          </p:cNvPr>
          <p:cNvSpPr txBox="1"/>
          <p:nvPr/>
        </p:nvSpPr>
        <p:spPr>
          <a:xfrm>
            <a:off x="4107581" y="1004054"/>
            <a:ext cx="6097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800" b="1" i="1" kern="100" dirty="0">
                <a:effectLst/>
                <a:latin typeface="Calibri" panose="020F050202020403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Figure 4 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569588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emertzidou, Anysia</dc:creator>
  <cp:lastModifiedBy>Semertzidou, Anysia</cp:lastModifiedBy>
  <cp:revision>1</cp:revision>
  <dcterms:created xsi:type="dcterms:W3CDTF">2025-10-06T13:36:09Z</dcterms:created>
  <dcterms:modified xsi:type="dcterms:W3CDTF">2025-10-30T16:10:05Z</dcterms:modified>
</cp:coreProperties>
</file>